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1D00C7-6113-4E0F-898E-BA86F1967D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A2CB6-626A-45D8-A691-D005319D77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415A77-D380-42D7-AA87-D9BD75825E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B95BF-633A-4C80-BF04-C378717E13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AB45E-E47A-43F8-B261-16CA449410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E44A85-9E72-4F51-BC2D-40729E34F1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E5CB83-F5F9-43A3-A950-D37240C846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FD15B-C36C-4394-A388-6326D2B75A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E7926-C346-46B1-9D03-440A4A4EFF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DBE81-11FB-4D9C-849B-8DBB19F6F5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BFD11-CC4E-4462-8C9F-A61BB755B3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A2FD1-D863-4F7D-9474-5F87CE0807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ＭＳ Ｐゴシック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ＭＳ Ｐ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0AEB50-2E13-4406-B2E6-56E4FD7A534D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723960" y="7881840"/>
            <a:ext cx="48751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1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HLELTEEQK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9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K VK 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12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VHFDECVK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21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QEK VSEEEATK LR 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35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NKDYANPTPAMK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46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47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CFGTCFFEK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55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IGTLK 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61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DGVVQEAVVLEK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72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73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LSPHFGEEK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81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VK AALDK CK NIK GADR CDTGFK 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104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IFECFEK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ourier New"/>
                <a:ea typeface="ＭＳ Ｐゴシック"/>
              </a:rPr>
              <a:t>110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K DELGH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28"/>
          <p:cNvSpPr/>
          <p:nvPr/>
        </p:nvSpPr>
        <p:spPr>
          <a:xfrm>
            <a:off x="335160" y="75009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29"/>
          <p:cNvSpPr/>
          <p:nvPr/>
        </p:nvSpPr>
        <p:spPr>
          <a:xfrm>
            <a:off x="297000" y="314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24" descr=""/>
          <p:cNvPicPr/>
          <p:nvPr/>
        </p:nvPicPr>
        <p:blipFill>
          <a:blip r:embed="rId1"/>
          <a:stretch/>
        </p:blipFill>
        <p:spPr>
          <a:xfrm>
            <a:off x="461880" y="754200"/>
            <a:ext cx="5934240" cy="6629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4T07:13:40Z</dcterms:created>
  <dc:creator>bruker application user</dc:creator>
  <dc:description/>
  <cp:keywords/>
  <dc:language>en-US</dc:language>
  <cp:lastModifiedBy>Yuko Ishida</cp:lastModifiedBy>
  <dcterms:modified xsi:type="dcterms:W3CDTF">2012-11-12T21:11:06Z</dcterms:modified>
  <cp:revision>21</cp:revision>
  <dc:subject/>
  <dc:title>Slide 1</dc:title>
</cp:coreProperties>
</file>